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4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-720" y="-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I:\&#31227;&#21160;&#30828;&#30424;\TOSHIBA%20EXT\1.27\&#24037;&#20316;\&#31185;&#30740;&#25104;&#26524;\&#35770;&#25991;\2022\&#33457;&#33469;&#20998;&#21270;&#36716;&#24405;&#32452;&#25968;&#25454;-&#28608;&#32032;\Figure%20S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I:\&#31227;&#21160;&#30828;&#30424;\TOSHIBA%20EXT\1.27\&#24037;&#20316;\&#31185;&#30740;&#25104;&#26524;\&#35770;&#25991;\2022\&#33457;&#33469;&#20998;&#21270;&#36716;&#24405;&#32452;&#25968;&#25454;-&#28608;&#32032;\Figure%20S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chart>
    <c:plotArea>
      <c:layout>
        <c:manualLayout>
          <c:layoutTarget val="inner"/>
          <c:xMode val="edge"/>
          <c:yMode val="edge"/>
          <c:x val="7.0599518810148768E-2"/>
          <c:y val="6.0659813356663754E-2"/>
          <c:w val="0.91551159230096202"/>
          <c:h val="0.81674358413531645"/>
        </c:manualLayout>
      </c:layout>
      <c:lineChart>
        <c:grouping val="standard"/>
        <c:ser>
          <c:idx val="0"/>
          <c:order val="0"/>
          <c:tx>
            <c:strRef>
              <c:f>'Mean temperature'!$C$2</c:f>
              <c:strCache>
                <c:ptCount val="1"/>
                <c:pt idx="0">
                  <c:v>2020-2021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strRef>
              <c:f>'Mean temperature'!$B$3:$B$11</c:f>
              <c:strCache>
                <c:ptCount val="9"/>
                <c:pt idx="0">
                  <c:v>Sep</c:v>
                </c:pt>
                <c:pt idx="1">
                  <c:v>Oct</c:v>
                </c:pt>
                <c:pt idx="2">
                  <c:v>Nov</c:v>
                </c:pt>
                <c:pt idx="3">
                  <c:v>Dec</c:v>
                </c:pt>
                <c:pt idx="4">
                  <c:v>Jan</c:v>
                </c:pt>
                <c:pt idx="5">
                  <c:v>Feb</c:v>
                </c:pt>
                <c:pt idx="6">
                  <c:v>Mar</c:v>
                </c:pt>
                <c:pt idx="7">
                  <c:v>Apr</c:v>
                </c:pt>
                <c:pt idx="8">
                  <c:v>May</c:v>
                </c:pt>
              </c:strCache>
            </c:strRef>
          </c:cat>
          <c:val>
            <c:numRef>
              <c:f>'Mean temperature'!$C$3:$C$11</c:f>
              <c:numCache>
                <c:formatCode>General</c:formatCode>
                <c:ptCount val="9"/>
                <c:pt idx="0">
                  <c:v>24.166666666666664</c:v>
                </c:pt>
                <c:pt idx="1">
                  <c:v>18.677419354838708</c:v>
                </c:pt>
                <c:pt idx="2">
                  <c:v>15</c:v>
                </c:pt>
                <c:pt idx="3">
                  <c:v>6.5035282258064511</c:v>
                </c:pt>
                <c:pt idx="4">
                  <c:v>6.6290322580645151</c:v>
                </c:pt>
                <c:pt idx="5">
                  <c:v>11.196428571428571</c:v>
                </c:pt>
                <c:pt idx="6">
                  <c:v>12.741935483870966</c:v>
                </c:pt>
                <c:pt idx="7">
                  <c:v>17.066666666666666</c:v>
                </c:pt>
                <c:pt idx="8">
                  <c:v>23.435483870967733</c:v>
                </c:pt>
              </c:numCache>
            </c:numRef>
          </c:val>
        </c:ser>
        <c:ser>
          <c:idx val="1"/>
          <c:order val="1"/>
          <c:tx>
            <c:strRef>
              <c:f>'Mean temperature'!$D$2</c:f>
              <c:strCache>
                <c:ptCount val="1"/>
                <c:pt idx="0">
                  <c:v>2021-2022</c:v>
                </c:pt>
              </c:strCache>
            </c:strRef>
          </c:tx>
          <c:spPr>
            <a:ln w="12700">
              <a:solidFill>
                <a:sysClr val="windowText" lastClr="000000"/>
              </a:solidFill>
            </a:ln>
          </c:spPr>
          <c:marker>
            <c:symbol val="circle"/>
            <c:size val="5"/>
            <c:spPr>
              <a:noFill/>
              <a:ln w="9525">
                <a:solidFill>
                  <a:sysClr val="windowText" lastClr="000000"/>
                </a:solidFill>
              </a:ln>
            </c:spPr>
          </c:marker>
          <c:cat>
            <c:strRef>
              <c:f>'Mean temperature'!$B$3:$B$11</c:f>
              <c:strCache>
                <c:ptCount val="9"/>
                <c:pt idx="0">
                  <c:v>Sep</c:v>
                </c:pt>
                <c:pt idx="1">
                  <c:v>Oct</c:v>
                </c:pt>
                <c:pt idx="2">
                  <c:v>Nov</c:v>
                </c:pt>
                <c:pt idx="3">
                  <c:v>Dec</c:v>
                </c:pt>
                <c:pt idx="4">
                  <c:v>Jan</c:v>
                </c:pt>
                <c:pt idx="5">
                  <c:v>Feb</c:v>
                </c:pt>
                <c:pt idx="6">
                  <c:v>Mar</c:v>
                </c:pt>
                <c:pt idx="7">
                  <c:v>Apr</c:v>
                </c:pt>
                <c:pt idx="8">
                  <c:v>May</c:v>
                </c:pt>
              </c:strCache>
            </c:strRef>
          </c:cat>
          <c:val>
            <c:numRef>
              <c:f>'Mean temperature'!$D$3:$D$11</c:f>
              <c:numCache>
                <c:formatCode>General</c:formatCode>
                <c:ptCount val="9"/>
                <c:pt idx="0">
                  <c:v>26.833333333333325</c:v>
                </c:pt>
                <c:pt idx="1">
                  <c:v>20.435483870967733</c:v>
                </c:pt>
                <c:pt idx="2">
                  <c:v>13.466666666666669</c:v>
                </c:pt>
                <c:pt idx="3">
                  <c:v>8.3870967741935498</c:v>
                </c:pt>
                <c:pt idx="4">
                  <c:v>6.0483870967741939</c:v>
                </c:pt>
                <c:pt idx="5">
                  <c:v>4.6964285714285703</c:v>
                </c:pt>
                <c:pt idx="6">
                  <c:v>15.677419354838712</c:v>
                </c:pt>
                <c:pt idx="7">
                  <c:v>17.849999999999994</c:v>
                </c:pt>
                <c:pt idx="8">
                  <c:v>20.806451612903224</c:v>
                </c:pt>
              </c:numCache>
            </c:numRef>
          </c:val>
        </c:ser>
        <c:marker val="1"/>
        <c:axId val="187386880"/>
        <c:axId val="187393152"/>
      </c:lineChart>
      <c:catAx>
        <c:axId val="187386880"/>
        <c:scaling>
          <c:orientation val="minMax"/>
        </c:scaling>
        <c:axPos val="b"/>
        <c:tickLblPos val="nextTo"/>
        <c:crossAx val="187393152"/>
        <c:crosses val="autoZero"/>
        <c:auto val="1"/>
        <c:lblAlgn val="ctr"/>
        <c:lblOffset val="100"/>
      </c:catAx>
      <c:valAx>
        <c:axId val="187393152"/>
        <c:scaling>
          <c:orientation val="minMax"/>
        </c:scaling>
        <c:axPos val="l"/>
        <c:majorGridlines>
          <c:spPr>
            <a:ln>
              <a:prstDash val="sysDot"/>
            </a:ln>
          </c:spPr>
        </c:majorGridlines>
        <c:numFmt formatCode="General" sourceLinked="1"/>
        <c:tickLblPos val="nextTo"/>
        <c:crossAx val="18738688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48994444444444452"/>
          <c:y val="8.7579104695246435E-2"/>
          <c:w val="0.20369444444444454"/>
          <c:h val="0.15707567804024497"/>
        </c:manualLayout>
      </c:layout>
    </c:legend>
    <c:plotVisOnly val="1"/>
  </c:chart>
  <c:txPr>
    <a:bodyPr/>
    <a:lstStyle/>
    <a:p>
      <a:pPr>
        <a:defRPr>
          <a:solidFill>
            <a:sysClr val="windowText" lastClr="000000"/>
          </a:solidFill>
          <a:latin typeface="Times New Roman" pitchFamily="18" charset="0"/>
          <a:cs typeface="Times New Roman" pitchFamily="18" charset="0"/>
        </a:defRPr>
      </a:pPr>
      <a:endParaRPr lang="zh-CN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zh-CN"/>
  <c:chart>
    <c:plotArea>
      <c:layout>
        <c:manualLayout>
          <c:layoutTarget val="inner"/>
          <c:xMode val="edge"/>
          <c:yMode val="edge"/>
          <c:x val="9.8571741032370999E-2"/>
          <c:y val="5.1400554097404488E-2"/>
          <c:w val="0.88581714785651755"/>
          <c:h val="0.79822506561679785"/>
        </c:manualLayout>
      </c:layout>
      <c:lineChart>
        <c:grouping val="standard"/>
        <c:ser>
          <c:idx val="0"/>
          <c:order val="0"/>
          <c:tx>
            <c:strRef>
              <c:f>'Mean temperature'!$M$2</c:f>
              <c:strCache>
                <c:ptCount val="1"/>
                <c:pt idx="0">
                  <c:v>2020-2021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</c:spPr>
          </c:marker>
          <c:cat>
            <c:strRef>
              <c:f>'Mean temperature'!$L$3:$L$11</c:f>
              <c:strCache>
                <c:ptCount val="9"/>
                <c:pt idx="0">
                  <c:v>Sep</c:v>
                </c:pt>
                <c:pt idx="1">
                  <c:v>Oct</c:v>
                </c:pt>
                <c:pt idx="2">
                  <c:v>Nov</c:v>
                </c:pt>
                <c:pt idx="3">
                  <c:v>Dec</c:v>
                </c:pt>
                <c:pt idx="4">
                  <c:v>Jan</c:v>
                </c:pt>
                <c:pt idx="5">
                  <c:v>Feb</c:v>
                </c:pt>
                <c:pt idx="6">
                  <c:v>Mar</c:v>
                </c:pt>
                <c:pt idx="7">
                  <c:v>Apr</c:v>
                </c:pt>
                <c:pt idx="8">
                  <c:v>May</c:v>
                </c:pt>
              </c:strCache>
            </c:strRef>
          </c:cat>
          <c:val>
            <c:numRef>
              <c:f>'Mean temperature'!$M$3:$M$11</c:f>
              <c:numCache>
                <c:formatCode>General</c:formatCode>
                <c:ptCount val="9"/>
                <c:pt idx="0">
                  <c:v>66.86</c:v>
                </c:pt>
                <c:pt idx="1">
                  <c:v>53.61</c:v>
                </c:pt>
                <c:pt idx="2">
                  <c:v>42.8</c:v>
                </c:pt>
                <c:pt idx="3">
                  <c:v>17.559999999999999</c:v>
                </c:pt>
                <c:pt idx="4">
                  <c:v>53.77</c:v>
                </c:pt>
                <c:pt idx="5">
                  <c:v>82.69</c:v>
                </c:pt>
                <c:pt idx="6">
                  <c:v>80</c:v>
                </c:pt>
                <c:pt idx="7">
                  <c:v>70.56</c:v>
                </c:pt>
                <c:pt idx="8">
                  <c:v>57.91</c:v>
                </c:pt>
              </c:numCache>
            </c:numRef>
          </c:val>
        </c:ser>
        <c:ser>
          <c:idx val="1"/>
          <c:order val="1"/>
          <c:tx>
            <c:strRef>
              <c:f>'Mean temperature'!$N$2</c:f>
              <c:strCache>
                <c:ptCount val="1"/>
                <c:pt idx="0">
                  <c:v>2021-2022</c:v>
                </c:pt>
              </c:strCache>
            </c:strRef>
          </c:tx>
          <c:spPr>
            <a:ln w="12700">
              <a:solidFill>
                <a:sysClr val="windowText" lastClr="000000"/>
              </a:solidFill>
            </a:ln>
          </c:spPr>
          <c:marker>
            <c:symbol val="circle"/>
            <c:size val="5"/>
            <c:spPr>
              <a:noFill/>
              <a:ln>
                <a:solidFill>
                  <a:sysClr val="windowText" lastClr="000000"/>
                </a:solidFill>
              </a:ln>
            </c:spPr>
          </c:marker>
          <c:cat>
            <c:strRef>
              <c:f>'Mean temperature'!$L$3:$L$11</c:f>
              <c:strCache>
                <c:ptCount val="9"/>
                <c:pt idx="0">
                  <c:v>Sep</c:v>
                </c:pt>
                <c:pt idx="1">
                  <c:v>Oct</c:v>
                </c:pt>
                <c:pt idx="2">
                  <c:v>Nov</c:v>
                </c:pt>
                <c:pt idx="3">
                  <c:v>Dec</c:v>
                </c:pt>
                <c:pt idx="4">
                  <c:v>Jan</c:v>
                </c:pt>
                <c:pt idx="5">
                  <c:v>Feb</c:v>
                </c:pt>
                <c:pt idx="6">
                  <c:v>Mar</c:v>
                </c:pt>
                <c:pt idx="7">
                  <c:v>Apr</c:v>
                </c:pt>
                <c:pt idx="8">
                  <c:v>May</c:v>
                </c:pt>
              </c:strCache>
            </c:strRef>
          </c:cat>
          <c:val>
            <c:numRef>
              <c:f>'Mean temperature'!$N$3:$N$11</c:f>
              <c:numCache>
                <c:formatCode>General</c:formatCode>
                <c:ptCount val="9"/>
                <c:pt idx="0">
                  <c:v>55.690000000000005</c:v>
                </c:pt>
                <c:pt idx="1">
                  <c:v>22.810000000000002</c:v>
                </c:pt>
                <c:pt idx="2">
                  <c:v>32.75</c:v>
                </c:pt>
                <c:pt idx="3">
                  <c:v>17.690000000000001</c:v>
                </c:pt>
                <c:pt idx="4">
                  <c:v>25.810000000000002</c:v>
                </c:pt>
                <c:pt idx="5">
                  <c:v>37.5</c:v>
                </c:pt>
                <c:pt idx="6">
                  <c:v>93.58</c:v>
                </c:pt>
                <c:pt idx="7">
                  <c:v>53.809999999999995</c:v>
                </c:pt>
                <c:pt idx="8">
                  <c:v>105.28</c:v>
                </c:pt>
              </c:numCache>
            </c:numRef>
          </c:val>
        </c:ser>
        <c:marker val="1"/>
        <c:axId val="187429632"/>
        <c:axId val="187431552"/>
      </c:lineChart>
      <c:catAx>
        <c:axId val="187429632"/>
        <c:scaling>
          <c:orientation val="minMax"/>
        </c:scaling>
        <c:axPos val="b"/>
        <c:tickLblPos val="nextTo"/>
        <c:crossAx val="187431552"/>
        <c:crosses val="autoZero"/>
        <c:auto val="1"/>
        <c:lblAlgn val="ctr"/>
        <c:lblOffset val="100"/>
      </c:catAx>
      <c:valAx>
        <c:axId val="187431552"/>
        <c:scaling>
          <c:orientation val="minMax"/>
        </c:scaling>
        <c:axPos val="l"/>
        <c:majorGridlines>
          <c:spPr>
            <a:ln>
              <a:prstDash val="sysDot"/>
            </a:ln>
          </c:spPr>
        </c:majorGridlines>
        <c:numFmt formatCode="General" sourceLinked="1"/>
        <c:tickLblPos val="nextTo"/>
        <c:crossAx val="18742963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3760555555555557"/>
          <c:y val="0.12461614173228359"/>
          <c:w val="0.20369444444444454"/>
          <c:h val="0.15707567804024497"/>
        </c:manualLayout>
      </c:layout>
    </c:legend>
    <c:plotVisOnly val="1"/>
  </c:chart>
  <c:txPr>
    <a:bodyPr/>
    <a:lstStyle/>
    <a:p>
      <a:pPr>
        <a:defRPr>
          <a:solidFill>
            <a:sysClr val="windowText" lastClr="000000"/>
          </a:solidFill>
          <a:latin typeface="Times New Roman" pitchFamily="18" charset="0"/>
          <a:cs typeface="Times New Roman" pitchFamily="18" charset="0"/>
        </a:defRPr>
      </a:pPr>
      <a:endParaRPr lang="zh-CN"/>
    </a:p>
  </c:tx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64F07157-7C4D-CBD6-0471-5CD47689539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="" xmlns:a16="http://schemas.microsoft.com/office/drawing/2014/main" id="{DE6776E4-B631-AFA9-0959-36D62C27980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94820F20-2374-C7DC-D247-71BA5320CC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BBA48-47B6-4E2E-AEB0-68C4B5732B20}" type="datetimeFigureOut">
              <a:rPr lang="zh-CN" altLang="en-US" smtClean="0"/>
              <a:pPr/>
              <a:t>2022/8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3B5C8818-068C-B3DC-7578-055A6EB134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66F4101C-0E52-8C72-335A-9528502D45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992D05-A1F2-4161-986F-D0FDDB23C68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6782707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2754C579-094B-9BB1-F0FB-82ED47A621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="" xmlns:a16="http://schemas.microsoft.com/office/drawing/2014/main" id="{8563A88A-CF81-7C7D-576B-55EFCFA461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B49F97B3-477D-9A83-9E99-CEFC9F019D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BBA48-47B6-4E2E-AEB0-68C4B5732B20}" type="datetimeFigureOut">
              <a:rPr lang="zh-CN" altLang="en-US" smtClean="0"/>
              <a:pPr/>
              <a:t>2022/8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4AD37AF3-439A-A5F7-6E57-9E4E8DF968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61BC1932-79FF-7DEB-B297-8561B54195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992D05-A1F2-4161-986F-D0FDDB23C68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11220020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="" xmlns:a16="http://schemas.microsoft.com/office/drawing/2014/main" id="{8AEDE113-E8A7-6DC0-CDC9-DD85D4201DE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="" xmlns:a16="http://schemas.microsoft.com/office/drawing/2014/main" id="{2E56441F-CD90-6544-748E-23DC2FEB0F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023C0D30-816F-E989-294A-7AEB5EB824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BBA48-47B6-4E2E-AEB0-68C4B5732B20}" type="datetimeFigureOut">
              <a:rPr lang="zh-CN" altLang="en-US" smtClean="0"/>
              <a:pPr/>
              <a:t>2022/8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776C582C-57A9-78D9-0756-B5C817234F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31120018-8D82-E4F9-2B6B-2EAEEDE86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992D05-A1F2-4161-986F-D0FDDB23C68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37764535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1247BA04-3508-FA5D-0BFA-8A87DD52F0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4258CBC3-F1D3-12B3-661D-5FB0EA26802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7BEFE511-C59B-655F-4802-7B7E53B5D4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BBA48-47B6-4E2E-AEB0-68C4B5732B20}" type="datetimeFigureOut">
              <a:rPr lang="zh-CN" altLang="en-US" smtClean="0"/>
              <a:pPr/>
              <a:t>2022/8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C285EB92-FA9C-567E-2137-F5DDFA9975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EEC926DB-0DA3-ADDA-1F79-9DD148E92B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992D05-A1F2-4161-986F-D0FDDB23C68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31825813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FAECA9BE-240C-7924-613B-B6F2521132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152464D0-5694-C877-4D27-87BC1E6255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6942820E-DF92-1CFC-34D4-3F790ECE7B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BBA48-47B6-4E2E-AEB0-68C4B5732B20}" type="datetimeFigureOut">
              <a:rPr lang="zh-CN" altLang="en-US" smtClean="0"/>
              <a:pPr/>
              <a:t>2022/8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7C441B68-7741-5B37-FBD9-EF7A1EAF94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35D7B18E-9377-265E-01F6-3D4D0DD2CB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992D05-A1F2-4161-986F-D0FDDB23C68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29494294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2FC935C1-015B-6084-AABB-62993F2971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2F304DAA-4A8B-AF0F-A6F1-EA59C62F218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="" xmlns:a16="http://schemas.microsoft.com/office/drawing/2014/main" id="{7DD3D7E0-C695-B18F-1EED-1844BBA01D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02D27D36-6EAC-AE72-CB1A-86AEB5D47F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BBA48-47B6-4E2E-AEB0-68C4B5732B20}" type="datetimeFigureOut">
              <a:rPr lang="zh-CN" altLang="en-US" smtClean="0"/>
              <a:pPr/>
              <a:t>2022/8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5E86D882-CA46-27A0-5F75-C5AD51D1DA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E878E2DB-5120-388A-8FFE-E61139F8A6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992D05-A1F2-4161-986F-D0FDDB23C68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42719667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69106884-20CB-E206-55BD-18DCEDC196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9A64A5C1-8FBE-E0CB-AADC-1ADB5F5F6E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="" xmlns:a16="http://schemas.microsoft.com/office/drawing/2014/main" id="{87C060BE-4D22-E022-84E2-BC48F4BDAD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="" xmlns:a16="http://schemas.microsoft.com/office/drawing/2014/main" id="{0B777F5C-204F-F87F-7435-70A0DA51934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="" xmlns:a16="http://schemas.microsoft.com/office/drawing/2014/main" id="{D30FD490-3671-6B5B-8CE0-57F250F7EB0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="" xmlns:a16="http://schemas.microsoft.com/office/drawing/2014/main" id="{CE26A3FD-1089-67DD-9EF2-633017CA01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BBA48-47B6-4E2E-AEB0-68C4B5732B20}" type="datetimeFigureOut">
              <a:rPr lang="zh-CN" altLang="en-US" smtClean="0"/>
              <a:pPr/>
              <a:t>2022/8/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="" xmlns:a16="http://schemas.microsoft.com/office/drawing/2014/main" id="{F104071D-E7E1-5832-E5C2-273F65B12E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="" xmlns:a16="http://schemas.microsoft.com/office/drawing/2014/main" id="{235E3B3D-2065-3D43-7719-75FF16A60B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992D05-A1F2-4161-986F-D0FDDB23C68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36105368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7867E18E-6BD1-4A1E-9DFD-D12B09EA69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="" xmlns:a16="http://schemas.microsoft.com/office/drawing/2014/main" id="{3DED059D-25E0-CB52-B538-F1BD6F9F89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BBA48-47B6-4E2E-AEB0-68C4B5732B20}" type="datetimeFigureOut">
              <a:rPr lang="zh-CN" altLang="en-US" smtClean="0"/>
              <a:pPr/>
              <a:t>2022/8/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="" xmlns:a16="http://schemas.microsoft.com/office/drawing/2014/main" id="{C10F5323-9782-CC3A-A74E-F166A327A9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="" xmlns:a16="http://schemas.microsoft.com/office/drawing/2014/main" id="{F911F935-82F3-68A1-5533-D6AFB99238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992D05-A1F2-4161-986F-D0FDDB23C68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18087440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="" xmlns:a16="http://schemas.microsoft.com/office/drawing/2014/main" id="{B0471AC6-6781-B51C-3CC4-CAA48C8647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BBA48-47B6-4E2E-AEB0-68C4B5732B20}" type="datetimeFigureOut">
              <a:rPr lang="zh-CN" altLang="en-US" smtClean="0"/>
              <a:pPr/>
              <a:t>2022/8/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="" xmlns:a16="http://schemas.microsoft.com/office/drawing/2014/main" id="{C51C5284-B011-728E-AFC8-9B1CE6869A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="" xmlns:a16="http://schemas.microsoft.com/office/drawing/2014/main" id="{CBE723D2-A0F7-85C2-AE52-D8B812A0B9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992D05-A1F2-4161-986F-D0FDDB23C68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33945104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4B7C06B1-DAC7-E087-C502-8877BB1A03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67CD1B9B-FA56-95AB-689A-B0DA286F42A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="" xmlns:a16="http://schemas.microsoft.com/office/drawing/2014/main" id="{053EE8F2-85C6-7B39-026D-F660FD40D9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4053E66D-253A-9835-E8DD-645FF83DFA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BBA48-47B6-4E2E-AEB0-68C4B5732B20}" type="datetimeFigureOut">
              <a:rPr lang="zh-CN" altLang="en-US" smtClean="0"/>
              <a:pPr/>
              <a:t>2022/8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10175E4D-DDB8-38F3-7CA3-64B8C15295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BE6180FC-C7F7-2CD4-BE78-6C27E80B5B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992D05-A1F2-4161-986F-D0FDDB23C68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22714215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478196AA-A412-C514-5132-B98B5838BE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="" xmlns:a16="http://schemas.microsoft.com/office/drawing/2014/main" id="{D9587DFD-AD28-E596-1012-5656A1A77CB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="" xmlns:a16="http://schemas.microsoft.com/office/drawing/2014/main" id="{C9F489A9-28C5-6E36-A217-E84DBB0A60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6A8A7B6D-42A7-A771-AE7B-C2C60DABA4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BBA48-47B6-4E2E-AEB0-68C4B5732B20}" type="datetimeFigureOut">
              <a:rPr lang="zh-CN" altLang="en-US" smtClean="0"/>
              <a:pPr/>
              <a:t>2022/8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571E7975-023E-AF2F-B12C-DE477BA13B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6E4565A6-4E3E-3117-AE3B-C158348FDA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992D05-A1F2-4161-986F-D0FDDB23C68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40683582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="" xmlns:a16="http://schemas.microsoft.com/office/drawing/2014/main" id="{BFC79CF8-59E1-E74B-064C-59D71B5F2A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78E2A8F7-24C6-F024-0135-AA10436D37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4B49BEC9-BDCB-15D9-CBAB-CBE4136FAC0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ABBA48-47B6-4E2E-AEB0-68C4B5732B20}" type="datetimeFigureOut">
              <a:rPr lang="zh-CN" altLang="en-US" smtClean="0"/>
              <a:pPr/>
              <a:t>2022/8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040EE513-017F-C7A1-399E-F2825737711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53202FA8-9A47-49F1-A6FE-18748F3C8FC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992D05-A1F2-4161-986F-D0FDDB23C68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29917860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="" xmlns:a16="http://schemas.microsoft.com/office/drawing/2014/main" id="{60E5EF66-9EC3-B4E6-D890-C9C1761D6606}"/>
              </a:ext>
            </a:extLst>
          </p:cNvPr>
          <p:cNvSpPr txBox="1"/>
          <p:nvPr/>
        </p:nvSpPr>
        <p:spPr>
          <a:xfrm rot="10800000" flipV="1">
            <a:off x="3038038" y="4468025"/>
            <a:ext cx="57161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 The growth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ditions during 2020-2021 and 2021-2022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图表 2"/>
          <p:cNvGraphicFramePr/>
          <p:nvPr/>
        </p:nvGraphicFramePr>
        <p:xfrm>
          <a:off x="938784" y="117957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图表 4"/>
          <p:cNvGraphicFramePr/>
          <p:nvPr/>
        </p:nvGraphicFramePr>
        <p:xfrm>
          <a:off x="6269736" y="1252728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2916936" y="3977640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Month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8912352" y="3938016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Month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-6202" y="2338262"/>
            <a:ext cx="16113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Mean temperature (</a:t>
            </a:r>
            <a:r>
              <a:rPr lang="en-US" altLang="zh-CN" sz="1200" dirty="0" smtClean="0">
                <a:latin typeface="Times New Roman"/>
                <a:cs typeface="Times New Roman"/>
              </a:rPr>
              <a:t>℃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16200000">
            <a:off x="5466999" y="2417510"/>
            <a:ext cx="10647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Rainfall (mm)</a:t>
            </a:r>
            <a:endParaRPr lang="zh-CN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39327761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="" xmlns:a16="http://schemas.microsoft.com/office/drawing/2014/main" id="{E5B9F22F-D884-3E7C-A503-E647ACFC8052}"/>
              </a:ext>
            </a:extLst>
          </p:cNvPr>
          <p:cNvSpPr txBox="1"/>
          <p:nvPr/>
        </p:nvSpPr>
        <p:spPr>
          <a:xfrm>
            <a:off x="1922768" y="4443072"/>
            <a:ext cx="172303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liques per plant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="" xmlns:a16="http://schemas.microsoft.com/office/drawing/2014/main" id="{44D86E73-69D2-EFAD-2710-9EC1635A2EF1}"/>
              </a:ext>
            </a:extLst>
          </p:cNvPr>
          <p:cNvSpPr txBox="1"/>
          <p:nvPr/>
        </p:nvSpPr>
        <p:spPr>
          <a:xfrm>
            <a:off x="4118969" y="1320800"/>
            <a:ext cx="36915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tio of floral meristems differentiation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="" xmlns:a16="http://schemas.microsoft.com/office/drawing/2014/main" id="{70585CCF-FAC0-D445-5019-423155340A82}"/>
              </a:ext>
            </a:extLst>
          </p:cNvPr>
          <p:cNvSpPr txBox="1"/>
          <p:nvPr/>
        </p:nvSpPr>
        <p:spPr>
          <a:xfrm>
            <a:off x="7982242" y="4443072"/>
            <a:ext cx="183793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ed yield per acre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直接箭头连接符 7">
            <a:extLst>
              <a:ext uri="{FF2B5EF4-FFF2-40B4-BE49-F238E27FC236}">
                <a16:creationId xmlns="" xmlns:a16="http://schemas.microsoft.com/office/drawing/2014/main" id="{F04DB872-FFB9-4DC7-A136-4ECE435EF30F}"/>
              </a:ext>
            </a:extLst>
          </p:cNvPr>
          <p:cNvCxnSpPr/>
          <p:nvPr/>
        </p:nvCxnSpPr>
        <p:spPr>
          <a:xfrm flipH="1">
            <a:off x="2956561" y="2011893"/>
            <a:ext cx="1709340" cy="2234987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>
            <a:extLst>
              <a:ext uri="{FF2B5EF4-FFF2-40B4-BE49-F238E27FC236}">
                <a16:creationId xmlns="" xmlns:a16="http://schemas.microsoft.com/office/drawing/2014/main" id="{A567913A-7EE3-20F4-0107-BB75F1F759FA}"/>
              </a:ext>
            </a:extLst>
          </p:cNvPr>
          <p:cNvSpPr txBox="1"/>
          <p:nvPr/>
        </p:nvSpPr>
        <p:spPr>
          <a:xfrm rot="18442179">
            <a:off x="2699407" y="2753511"/>
            <a:ext cx="16850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991/0.999/0.992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" name="直接箭头连接符 9">
            <a:extLst>
              <a:ext uri="{FF2B5EF4-FFF2-40B4-BE49-F238E27FC236}">
                <a16:creationId xmlns="" xmlns:a16="http://schemas.microsoft.com/office/drawing/2014/main" id="{D59016D7-BB9E-085B-59A6-CF0ED1237A16}"/>
              </a:ext>
            </a:extLst>
          </p:cNvPr>
          <p:cNvCxnSpPr>
            <a:cxnSpLocks/>
          </p:cNvCxnSpPr>
          <p:nvPr/>
        </p:nvCxnSpPr>
        <p:spPr>
          <a:xfrm flipH="1" flipV="1">
            <a:off x="7223761" y="2011895"/>
            <a:ext cx="1709340" cy="2234987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="" xmlns:a16="http://schemas.microsoft.com/office/drawing/2014/main" id="{B5CAC9C7-64D4-CFB0-A005-8634722EE7CC}"/>
              </a:ext>
            </a:extLst>
          </p:cNvPr>
          <p:cNvSpPr txBox="1"/>
          <p:nvPr/>
        </p:nvSpPr>
        <p:spPr>
          <a:xfrm rot="13929511" flipV="1">
            <a:off x="7500408" y="2750327"/>
            <a:ext cx="16850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978/0.992/0.977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接箭头连接符 11">
            <a:extLst>
              <a:ext uri="{FF2B5EF4-FFF2-40B4-BE49-F238E27FC236}">
                <a16:creationId xmlns="" xmlns:a16="http://schemas.microsoft.com/office/drawing/2014/main" id="{9C5404EF-01A0-CB98-1F9A-63C9CB2E5E5A}"/>
              </a:ext>
            </a:extLst>
          </p:cNvPr>
          <p:cNvCxnSpPr>
            <a:cxnSpLocks/>
          </p:cNvCxnSpPr>
          <p:nvPr/>
        </p:nvCxnSpPr>
        <p:spPr>
          <a:xfrm flipH="1">
            <a:off x="4286381" y="4627931"/>
            <a:ext cx="3140580" cy="0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本框 14">
            <a:extLst>
              <a:ext uri="{FF2B5EF4-FFF2-40B4-BE49-F238E27FC236}">
                <a16:creationId xmlns="" xmlns:a16="http://schemas.microsoft.com/office/drawing/2014/main" id="{0B415223-697C-7752-244D-EC0EAFDDA04B}"/>
              </a:ext>
            </a:extLst>
          </p:cNvPr>
          <p:cNvSpPr txBox="1"/>
          <p:nvPr/>
        </p:nvSpPr>
        <p:spPr>
          <a:xfrm rot="10800000" flipV="1">
            <a:off x="5000682" y="4726193"/>
            <a:ext cx="16850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996/0.997/0.997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="" xmlns:a16="http://schemas.microsoft.com/office/drawing/2014/main" id="{0B45BD8E-E862-F453-C04B-7E162B58C795}"/>
              </a:ext>
            </a:extLst>
          </p:cNvPr>
          <p:cNvSpPr txBox="1"/>
          <p:nvPr/>
        </p:nvSpPr>
        <p:spPr>
          <a:xfrm rot="10800000" flipV="1">
            <a:off x="501027" y="5460483"/>
            <a:ext cx="1088156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 Correlation analysis between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atio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floral meristems differentiation, siliques per plant and seed yield per acre. </a:t>
            </a:r>
          </a:p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values above the  double sided arrows represent the correlation coefficients at  30</a:t>
            </a:r>
            <a:r>
              <a:rPr lang="en-US" altLang="zh-CN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ov, 04</a:t>
            </a:r>
            <a:r>
              <a:rPr lang="en-US" altLang="zh-CN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c, and 07</a:t>
            </a:r>
            <a:r>
              <a:rPr lang="en-US" altLang="zh-CN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c, respectively. 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17816312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79</Words>
  <Application>Microsoft Office PowerPoint</Application>
  <PresentationFormat>自定义</PresentationFormat>
  <Paragraphs>13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主题​​</vt:lpstr>
      <vt:lpstr>幻灯片 1</vt:lpstr>
      <vt:lpstr>幻灯片 2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郝 鹏飞</dc:creator>
  <cp:lastModifiedBy>PC</cp:lastModifiedBy>
  <cp:revision>4</cp:revision>
  <dcterms:created xsi:type="dcterms:W3CDTF">2022-07-10T05:19:06Z</dcterms:created>
  <dcterms:modified xsi:type="dcterms:W3CDTF">2022-08-02T01:12:42Z</dcterms:modified>
</cp:coreProperties>
</file>